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4"/>
  </p:handoutMasterIdLst>
  <p:sldIdLst>
    <p:sldId id="763" r:id="rId2"/>
    <p:sldId id="768" r:id="rId3"/>
    <p:sldId id="767" r:id="rId4"/>
    <p:sldId id="754" r:id="rId5"/>
    <p:sldId id="755" r:id="rId6"/>
    <p:sldId id="756" r:id="rId7"/>
    <p:sldId id="757" r:id="rId8"/>
    <p:sldId id="758" r:id="rId9"/>
    <p:sldId id="759" r:id="rId10"/>
    <p:sldId id="765" r:id="rId11"/>
    <p:sldId id="762" r:id="rId12"/>
    <p:sldId id="764" r:id="rId1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1E21E21-9CE3-44AD-A865-CF686E89E079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012DD4D0-B7E4-4F3C-9509-AC73278E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28348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761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156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114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565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99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414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220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35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873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452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550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93BB3F-8A92-4785-B453-99EAE49F9DC7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DAE4A4-3550-48D3-AA48-B29E806DE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360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6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9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image" Target="../media/image5.png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13" Type="http://schemas.openxmlformats.org/officeDocument/2006/relationships/image" Target="../media/image22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12" Type="http://schemas.openxmlformats.org/officeDocument/2006/relationships/image" Target="../media/image21.tiff"/><Relationship Id="rId17" Type="http://schemas.openxmlformats.org/officeDocument/2006/relationships/image" Target="../media/image26.tiff"/><Relationship Id="rId2" Type="http://schemas.openxmlformats.org/officeDocument/2006/relationships/image" Target="../media/image11.tiff"/><Relationship Id="rId16" Type="http://schemas.openxmlformats.org/officeDocument/2006/relationships/image" Target="../media/image2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11" Type="http://schemas.openxmlformats.org/officeDocument/2006/relationships/image" Target="../media/image20.tiff"/><Relationship Id="rId5" Type="http://schemas.openxmlformats.org/officeDocument/2006/relationships/image" Target="../media/image14.tiff"/><Relationship Id="rId15" Type="http://schemas.openxmlformats.org/officeDocument/2006/relationships/image" Target="../media/image24.tiff"/><Relationship Id="rId10" Type="http://schemas.openxmlformats.org/officeDocument/2006/relationships/image" Target="../media/image19.tiff"/><Relationship Id="rId4" Type="http://schemas.openxmlformats.org/officeDocument/2006/relationships/image" Target="../media/image13.tiff"/><Relationship Id="rId9" Type="http://schemas.openxmlformats.org/officeDocument/2006/relationships/image" Target="../media/image18.tiff"/><Relationship Id="rId14" Type="http://schemas.openxmlformats.org/officeDocument/2006/relationships/image" Target="../media/image2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5f35a784-b2a5-46cb-9ecb-cbdbecd1b5ed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2654" y="1560888"/>
            <a:ext cx="5097758" cy="514035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a03748d8-6f0d-42f8-9ba7-93dd578c643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5211" y="1553068"/>
            <a:ext cx="5169511" cy="514817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107570" y="0"/>
            <a:ext cx="1175350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emonstration of drug synergy using combination index (CI) values. 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) CLF+PI; B)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CLF+IMi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s were treated as combination and CI values were calculated for each fraction affected (FA; fraction of cells affected/killed)) using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alcusy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oftware that applies a method proposed by Chou and Talalay's.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I value of less than 0.9 indicates synergism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9AAD09-4A88-464C-85EB-03BC3313453F}"/>
              </a:ext>
            </a:extLst>
          </p:cNvPr>
          <p:cNvSpPr txBox="1"/>
          <p:nvPr/>
        </p:nvSpPr>
        <p:spPr>
          <a:xfrm>
            <a:off x="160404" y="1560888"/>
            <a:ext cx="762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29F784-1280-486D-9C70-3774899AEAC2}"/>
              </a:ext>
            </a:extLst>
          </p:cNvPr>
          <p:cNvSpPr txBox="1"/>
          <p:nvPr/>
        </p:nvSpPr>
        <p:spPr>
          <a:xfrm>
            <a:off x="6092164" y="1553068"/>
            <a:ext cx="7261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1B. 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72783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0" t="3499" r="2724" b="3315"/>
          <a:stretch/>
        </p:blipFill>
        <p:spPr>
          <a:xfrm>
            <a:off x="3578469" y="1569660"/>
            <a:ext cx="5213839" cy="5122722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0"/>
            <a:ext cx="12045462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Figure S8. Ingenuity Pathway Analysis (IPA) based on the top dysregulated genes following </a:t>
            </a:r>
            <a:r>
              <a:rPr lang="en-US" sz="2400" b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LF+Ixazomib</a:t>
            </a:r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combination treatment showed downregulation of the </a:t>
            </a:r>
            <a:r>
              <a:rPr lang="en-US" sz="2400" b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mTOR</a:t>
            </a:r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signaling gene RICTOR as one of the top predictions.</a:t>
            </a: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RICTOR - Rapamycin-insensitive companion of mammalian target of rapamycin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4168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3E8692A1-3AC9-455B-9187-426DD2B367F8}"/>
              </a:ext>
            </a:extLst>
          </p:cNvPr>
          <p:cNvSpPr txBox="1"/>
          <p:nvPr/>
        </p:nvSpPr>
        <p:spPr>
          <a:xfrm>
            <a:off x="68162" y="18974"/>
            <a:ext cx="12038846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9: CLF response is independent of AHR expression</a:t>
            </a:r>
          </a:p>
          <a:p>
            <a:pPr marL="457200" indent="-457200">
              <a:buAutoNum type="alphaUcPeriod"/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catter plot representing bivariate relationship between relative AHR mRNA expression vs CLF IC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in a panel of myeloma cell lines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F treatment response was not significantly correlated with AHR expression.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arplot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representing cytotoxicity data (IC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 of the AHR antagonist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temRegenin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1 (SR1). 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 Scatter plot shows SR1 response was correlated with baseline AHR expressi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251658-F41B-4DF0-A4EB-664E6E6E57D6}"/>
              </a:ext>
            </a:extLst>
          </p:cNvPr>
          <p:cNvSpPr txBox="1"/>
          <p:nvPr/>
        </p:nvSpPr>
        <p:spPr>
          <a:xfrm>
            <a:off x="1144109" y="6412290"/>
            <a:ext cx="376626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Log (relative AHR mRNA expression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F2F489B-DCF1-4BCF-9BA1-6AD45FBE3B59}"/>
              </a:ext>
            </a:extLst>
          </p:cNvPr>
          <p:cNvSpPr txBox="1"/>
          <p:nvPr/>
        </p:nvSpPr>
        <p:spPr>
          <a:xfrm>
            <a:off x="1022659" y="1817543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9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206270A-18D9-4FF3-99A2-07D2B7ABC401}"/>
              </a:ext>
            </a:extLst>
          </p:cNvPr>
          <p:cNvSpPr txBox="1"/>
          <p:nvPr/>
        </p:nvSpPr>
        <p:spPr>
          <a:xfrm>
            <a:off x="5401270" y="1849563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9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2" t="10299" r="3423" b="7629"/>
          <a:stretch/>
        </p:blipFill>
        <p:spPr>
          <a:xfrm>
            <a:off x="709805" y="2138006"/>
            <a:ext cx="4634876" cy="419838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2251658-F41B-4DF0-A4EB-664E6E6E57D6}"/>
              </a:ext>
            </a:extLst>
          </p:cNvPr>
          <p:cNvSpPr txBox="1"/>
          <p:nvPr/>
        </p:nvSpPr>
        <p:spPr>
          <a:xfrm rot="16200000">
            <a:off x="-1162669" y="3909831"/>
            <a:ext cx="295401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Log (CLF IC</a:t>
            </a:r>
            <a:r>
              <a:rPr lang="en-US" b="1" baseline="-25000" dirty="0"/>
              <a:t>50</a:t>
            </a:r>
            <a:r>
              <a:rPr lang="en-US" b="1" dirty="0"/>
              <a:t>)</a:t>
            </a:r>
          </a:p>
        </p:txBody>
      </p:sp>
      <p:sp>
        <p:nvSpPr>
          <p:cNvPr id="15" name="Rectangle 14"/>
          <p:cNvSpPr/>
          <p:nvPr/>
        </p:nvSpPr>
        <p:spPr>
          <a:xfrm>
            <a:off x="3419137" y="2318046"/>
            <a:ext cx="159851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</a:rPr>
              <a:t>Spearman r = -0.14 </a:t>
            </a:r>
          </a:p>
          <a:p>
            <a:r>
              <a:rPr lang="en-US" sz="1200" b="1" dirty="0"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</a:rPr>
              <a:t>p-value = 0.75</a:t>
            </a:r>
            <a:endParaRPr lang="en-US" sz="12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868F3D9-8F5D-4898-B7C0-CA5E7CA725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5005" t="15455"/>
          <a:stretch/>
        </p:blipFill>
        <p:spPr>
          <a:xfrm>
            <a:off x="5504436" y="2278226"/>
            <a:ext cx="2898438" cy="37233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AC9FA2-F391-49B9-912A-970C03DFE161}"/>
              </a:ext>
            </a:extLst>
          </p:cNvPr>
          <p:cNvSpPr txBox="1"/>
          <p:nvPr/>
        </p:nvSpPr>
        <p:spPr>
          <a:xfrm>
            <a:off x="5787464" y="5629380"/>
            <a:ext cx="233238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R1 IC</a:t>
            </a:r>
            <a:r>
              <a:rPr lang="en-US" b="1" baseline="-25000" dirty="0"/>
              <a:t>50</a:t>
            </a:r>
            <a:r>
              <a:rPr lang="en-US" b="1" dirty="0"/>
              <a:t>(</a:t>
            </a:r>
            <a:r>
              <a:rPr lang="en-US" b="1" dirty="0" err="1"/>
              <a:t>nM</a:t>
            </a:r>
            <a:r>
              <a:rPr lang="en-US" b="1" dirty="0"/>
              <a:t>)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7868F3D9-8F5D-4898-B7C0-CA5E7CA725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2549" t="10420" r="30624" b="82361"/>
          <a:stretch/>
        </p:blipFill>
        <p:spPr>
          <a:xfrm>
            <a:off x="5504436" y="6120235"/>
            <a:ext cx="2898438" cy="3021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2" t="10627" r="3044" b="7419"/>
          <a:stretch/>
        </p:blipFill>
        <p:spPr>
          <a:xfrm>
            <a:off x="8889022" y="2278226"/>
            <a:ext cx="3217986" cy="283991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52251658-F41B-4DF0-A4EB-664E6E6E57D6}"/>
              </a:ext>
            </a:extLst>
          </p:cNvPr>
          <p:cNvSpPr txBox="1"/>
          <p:nvPr/>
        </p:nvSpPr>
        <p:spPr>
          <a:xfrm>
            <a:off x="8769970" y="5050132"/>
            <a:ext cx="342203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Log (relative AHR mRNA expression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2251658-F41B-4DF0-A4EB-664E6E6E57D6}"/>
              </a:ext>
            </a:extLst>
          </p:cNvPr>
          <p:cNvSpPr txBox="1"/>
          <p:nvPr/>
        </p:nvSpPr>
        <p:spPr>
          <a:xfrm rot="16200000">
            <a:off x="7320249" y="3542346"/>
            <a:ext cx="295401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Log (SR1 IC</a:t>
            </a:r>
            <a:r>
              <a:rPr lang="en-US" b="1" baseline="-25000" dirty="0"/>
              <a:t>50</a:t>
            </a:r>
            <a:r>
              <a:rPr lang="en-US" b="1" dirty="0"/>
              <a:t>)</a:t>
            </a:r>
          </a:p>
        </p:txBody>
      </p:sp>
      <p:sp>
        <p:nvSpPr>
          <p:cNvPr id="20" name="Rectangle 19"/>
          <p:cNvSpPr/>
          <p:nvPr/>
        </p:nvSpPr>
        <p:spPr>
          <a:xfrm>
            <a:off x="10480985" y="2346664"/>
            <a:ext cx="1470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</a:rPr>
              <a:t>Spearman r = -0.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206270A-18D9-4FF3-99A2-07D2B7ABC401}"/>
              </a:ext>
            </a:extLst>
          </p:cNvPr>
          <p:cNvSpPr txBox="1"/>
          <p:nvPr/>
        </p:nvSpPr>
        <p:spPr>
          <a:xfrm>
            <a:off x="8701316" y="1817543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9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87399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8692A1-3AC9-455B-9187-426DD2B367F8}"/>
              </a:ext>
            </a:extLst>
          </p:cNvPr>
          <p:cNvSpPr txBox="1"/>
          <p:nvPr/>
        </p:nvSpPr>
        <p:spPr>
          <a:xfrm>
            <a:off x="68162" y="18974"/>
            <a:ext cx="11819037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10: Larger Western blots of PARP cleavage and caspase cleavage showing that CLF treatment induces apoptosis in sensitive and innate resistant MM cell lines. </a:t>
            </a:r>
          </a:p>
          <a:p>
            <a:pPr marL="457200" indent="-457200">
              <a:buAutoNum type="alphaUcPeriod"/>
            </a:pP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PARP cleavage; B. Caspase-3 cleavage; </a:t>
            </a:r>
          </a:p>
          <a:p>
            <a:pPr marL="457200" indent="-457200">
              <a:buAutoNum type="alphaUcPeriod"/>
            </a:pPr>
            <a:endParaRPr lang="en-US" sz="2400" dirty="0"/>
          </a:p>
        </p:txBody>
      </p:sp>
      <p:grpSp>
        <p:nvGrpSpPr>
          <p:cNvPr id="25" name="Group 24"/>
          <p:cNvGrpSpPr/>
          <p:nvPr/>
        </p:nvGrpSpPr>
        <p:grpSpPr>
          <a:xfrm>
            <a:off x="164856" y="1957967"/>
            <a:ext cx="4773185" cy="3581188"/>
            <a:chOff x="0" y="-718572"/>
            <a:chExt cx="7809037" cy="6965801"/>
          </a:xfrm>
        </p:grpSpPr>
        <p:pic>
          <p:nvPicPr>
            <p:cNvPr id="26" name="Picture 25" descr="A picture containing table, snow, sitting, photo&#10;&#10;Description automatically generated">
              <a:extLst>
                <a:ext uri="{FF2B5EF4-FFF2-40B4-BE49-F238E27FC236}">
                  <a16:creationId xmlns:a16="http://schemas.microsoft.com/office/drawing/2014/main" id="{52C1B740-33FF-4C0A-B5BB-1D6F370670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/>
          </p:blipFill>
          <p:spPr>
            <a:xfrm>
              <a:off x="0" y="-1"/>
              <a:ext cx="7809037" cy="62472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7" name="TextBox 3">
              <a:extLst>
                <a:ext uri="{FF2B5EF4-FFF2-40B4-BE49-F238E27FC236}">
                  <a16:creationId xmlns:a16="http://schemas.microsoft.com/office/drawing/2014/main" id="{570E16CB-987E-4FEC-97FB-C793918F028D}"/>
                </a:ext>
              </a:extLst>
            </p:cNvPr>
            <p:cNvSpPr txBox="1"/>
            <p:nvPr/>
          </p:nvSpPr>
          <p:spPr>
            <a:xfrm>
              <a:off x="0" y="-718572"/>
              <a:ext cx="4174953" cy="67954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leaved PARP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6B545498-57F0-42B4-BB7C-7DEAB475E88F}"/>
                </a:ext>
              </a:extLst>
            </p:cNvPr>
            <p:cNvSpPr/>
            <p:nvPr/>
          </p:nvSpPr>
          <p:spPr>
            <a:xfrm>
              <a:off x="2437384" y="2806330"/>
              <a:ext cx="2131196" cy="63456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29" name="TextBox 8">
              <a:extLst>
                <a:ext uri="{FF2B5EF4-FFF2-40B4-BE49-F238E27FC236}">
                  <a16:creationId xmlns:a16="http://schemas.microsoft.com/office/drawing/2014/main" id="{45F4AB39-A250-4FBC-80D2-519F175937FB}"/>
                </a:ext>
              </a:extLst>
            </p:cNvPr>
            <p:cNvSpPr txBox="1"/>
            <p:nvPr/>
          </p:nvSpPr>
          <p:spPr>
            <a:xfrm>
              <a:off x="2132490" y="1848694"/>
              <a:ext cx="2511029" cy="61328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RPMI8226-P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0" name="TextBox 9">
              <a:extLst>
                <a:ext uri="{FF2B5EF4-FFF2-40B4-BE49-F238E27FC236}">
                  <a16:creationId xmlns:a16="http://schemas.microsoft.com/office/drawing/2014/main" id="{079495D4-344A-4816-B0D8-D2FBC33C4247}"/>
                </a:ext>
              </a:extLst>
            </p:cNvPr>
            <p:cNvSpPr txBox="1"/>
            <p:nvPr/>
          </p:nvSpPr>
          <p:spPr>
            <a:xfrm>
              <a:off x="4697884" y="1887475"/>
              <a:ext cx="2968016" cy="63046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RPMI8226-VR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5D37BFA8-F0C9-4B9C-A93D-93501F2A9E0B}"/>
                </a:ext>
              </a:extLst>
            </p:cNvPr>
            <p:cNvSpPr/>
            <p:nvPr/>
          </p:nvSpPr>
          <p:spPr>
            <a:xfrm>
              <a:off x="4704334" y="2672980"/>
              <a:ext cx="2131196" cy="63456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5034735" y="1957966"/>
            <a:ext cx="6713260" cy="2570145"/>
            <a:chOff x="9236" y="-620614"/>
            <a:chExt cx="8380790" cy="3924646"/>
          </a:xfrm>
        </p:grpSpPr>
        <p:grpSp>
          <p:nvGrpSpPr>
            <p:cNvPr id="35" name="Group 34"/>
            <p:cNvGrpSpPr/>
            <p:nvPr/>
          </p:nvGrpSpPr>
          <p:grpSpPr>
            <a:xfrm>
              <a:off x="9236" y="0"/>
              <a:ext cx="8380790" cy="3304032"/>
              <a:chOff x="9236" y="0"/>
              <a:chExt cx="8380790" cy="3304032"/>
            </a:xfrm>
          </p:grpSpPr>
          <p:pic>
            <p:nvPicPr>
              <p:cNvPr id="45" name="Picture 44" descr="A picture containing white, cat, water, drawing&#10;&#10;Description automatically generated">
                <a:extLst>
                  <a:ext uri="{FF2B5EF4-FFF2-40B4-BE49-F238E27FC236}">
                    <a16:creationId xmlns:a16="http://schemas.microsoft.com/office/drawing/2014/main" id="{8CBAFC76-08B8-4B6F-AFB7-9CF1CEBA390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/>
            </p:blipFill>
            <p:spPr>
              <a:xfrm>
                <a:off x="9236" y="0"/>
                <a:ext cx="4130039" cy="330403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6" name="Picture 45" descr="A picture containing white, bird, photo, dog&#10;&#10;Description automatically generated">
                <a:extLst>
                  <a:ext uri="{FF2B5EF4-FFF2-40B4-BE49-F238E27FC236}">
                    <a16:creationId xmlns:a16="http://schemas.microsoft.com/office/drawing/2014/main" id="{852B5424-1E63-4A80-8A22-E045F8DD35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/>
            </p:blipFill>
            <p:spPr>
              <a:xfrm>
                <a:off x="4259987" y="0"/>
                <a:ext cx="4130039" cy="330403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4978BD16-C456-4958-A374-0BDB10F2B4D4}"/>
                  </a:ext>
                </a:extLst>
              </p:cNvPr>
              <p:cNvSpPr/>
              <p:nvPr/>
            </p:nvSpPr>
            <p:spPr>
              <a:xfrm>
                <a:off x="1579852" y="1431691"/>
                <a:ext cx="1416730" cy="684138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7F56FB3C-C286-49EF-A929-1E0C2A80A058}"/>
                  </a:ext>
                </a:extLst>
              </p:cNvPr>
              <p:cNvSpPr/>
              <p:nvPr/>
            </p:nvSpPr>
            <p:spPr>
              <a:xfrm>
                <a:off x="5502435" y="1801024"/>
                <a:ext cx="1331096" cy="60303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/>
              </a:p>
            </p:txBody>
          </p:sp>
        </p:grp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4978BD16-C456-4958-A374-0BDB10F2B4D4}"/>
                </a:ext>
              </a:extLst>
            </p:cNvPr>
            <p:cNvSpPr/>
            <p:nvPr/>
          </p:nvSpPr>
          <p:spPr>
            <a:xfrm>
              <a:off x="1570616" y="1440927"/>
              <a:ext cx="1416730" cy="684139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 flipH="1">
              <a:off x="6810959" y="1341831"/>
              <a:ext cx="419013" cy="410729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20">
              <a:extLst>
                <a:ext uri="{FF2B5EF4-FFF2-40B4-BE49-F238E27FC236}">
                  <a16:creationId xmlns:a16="http://schemas.microsoft.com/office/drawing/2014/main" id="{AD195908-2C0A-459E-9111-44F598999974}"/>
                </a:ext>
              </a:extLst>
            </p:cNvPr>
            <p:cNvSpPr txBox="1"/>
            <p:nvPr/>
          </p:nvSpPr>
          <p:spPr>
            <a:xfrm>
              <a:off x="419401" y="-620614"/>
              <a:ext cx="2921000" cy="73692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leaved Caspase-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9" name="TextBox 21">
              <a:extLst>
                <a:ext uri="{FF2B5EF4-FFF2-40B4-BE49-F238E27FC236}">
                  <a16:creationId xmlns:a16="http://schemas.microsoft.com/office/drawing/2014/main" id="{AD195908-2C0A-459E-9111-44F598999974}"/>
                </a:ext>
              </a:extLst>
            </p:cNvPr>
            <p:cNvSpPr txBox="1"/>
            <p:nvPr/>
          </p:nvSpPr>
          <p:spPr>
            <a:xfrm>
              <a:off x="1714771" y="800907"/>
              <a:ext cx="2021576" cy="60507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RPMI-P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0" name="TextBox 22">
              <a:extLst>
                <a:ext uri="{FF2B5EF4-FFF2-40B4-BE49-F238E27FC236}">
                  <a16:creationId xmlns:a16="http://schemas.microsoft.com/office/drawing/2014/main" id="{AD195908-2C0A-459E-9111-44F598999974}"/>
                </a:ext>
              </a:extLst>
            </p:cNvPr>
            <p:cNvSpPr txBox="1"/>
            <p:nvPr/>
          </p:nvSpPr>
          <p:spPr>
            <a:xfrm>
              <a:off x="5441882" y="788813"/>
              <a:ext cx="1869441" cy="6060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RPMI-VR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40221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0664" y="16974"/>
            <a:ext cx="1198435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A-B: Effect of CLF-treatment on the induction of apoptosis in myeloma. </a:t>
            </a:r>
          </a:p>
          <a:p>
            <a:pPr marL="342900" indent="-342900">
              <a:buAutoNum type="alphaU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spase 3/7 Assay; Caspase-3/7 activity assays were performed using Caspase-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Glo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3/7 luminescent assay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romeg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Madison, WI) using Synergy 2 Microplate Reader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iotek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pPr marL="342900" indent="-342900">
              <a:buFontTx/>
              <a:buAutoNum type="alphaU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ditional western blotting images and densitometry plots showing downregulation of caspase-3 and caspase-9 following CLF treatment in PI-sensitive (FLAM76) and PI-resistant (LP1) myeloma cell line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11553"/>
          <a:stretch/>
        </p:blipFill>
        <p:spPr>
          <a:xfrm>
            <a:off x="175844" y="2015656"/>
            <a:ext cx="5840140" cy="39279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93335" y="2030887"/>
            <a:ext cx="5020056" cy="1927938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83BA2D2-7938-4CC1-83E1-C27F59BF9B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7567667"/>
              </p:ext>
            </p:extLst>
          </p:nvPr>
        </p:nvGraphicFramePr>
        <p:xfrm>
          <a:off x="9103364" y="3988844"/>
          <a:ext cx="2991654" cy="19547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8" r:id="rId5" imgW="4268338" imgH="2788623" progId="Prism8.Document">
                  <p:embed/>
                </p:oleObj>
              </mc:Choice>
              <mc:Fallback>
                <p:oleObj name="Prism 8" r:id="rId5" imgW="4268338" imgH="2788623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83BA2D2-7938-4CC1-83E1-C27F59BF9B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103364" y="3988844"/>
                        <a:ext cx="2991654" cy="19547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12CD3074-C554-4CA5-8AE8-3F5AC4F8B4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9837661"/>
              </p:ext>
            </p:extLst>
          </p:nvPr>
        </p:nvGraphicFramePr>
        <p:xfrm>
          <a:off x="6111709" y="3988844"/>
          <a:ext cx="2991654" cy="19547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8" r:id="rId7" imgW="4268338" imgH="2788623" progId="Prism8.Document">
                  <p:embed/>
                </p:oleObj>
              </mc:Choice>
              <mc:Fallback>
                <p:oleObj name="Prism 8" r:id="rId7" imgW="4268338" imgH="2788623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2CD3074-C554-4CA5-8AE8-3F5AC4F8B4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11709" y="3988844"/>
                        <a:ext cx="2991654" cy="19547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10664" y="16615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111317" y="16615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635632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2EB55F0-C76B-4787-816D-6FBB5C187A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119"/>
          <a:stretch/>
        </p:blipFill>
        <p:spPr>
          <a:xfrm>
            <a:off x="691689" y="1758630"/>
            <a:ext cx="4933950" cy="494245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21A9448-73BB-4276-B447-4F7BA8E8A7F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221"/>
          <a:stretch/>
        </p:blipFill>
        <p:spPr>
          <a:xfrm>
            <a:off x="6273339" y="1758630"/>
            <a:ext cx="5562600" cy="5025648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86A20CD6-F75D-4C4F-9128-B08006CE6FBC}"/>
              </a:ext>
            </a:extLst>
          </p:cNvPr>
          <p:cNvSpPr/>
          <p:nvPr/>
        </p:nvSpPr>
        <p:spPr>
          <a:xfrm>
            <a:off x="10107099" y="1350891"/>
            <a:ext cx="379379" cy="12645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0AE02F9-4350-4248-B1AC-E53EA609C9FB}"/>
              </a:ext>
            </a:extLst>
          </p:cNvPr>
          <p:cNvSpPr/>
          <p:nvPr/>
        </p:nvSpPr>
        <p:spPr>
          <a:xfrm>
            <a:off x="10107098" y="1655691"/>
            <a:ext cx="379379" cy="126459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414F96C-318F-40C7-BBFD-AD5EAC6CC0DB}"/>
              </a:ext>
            </a:extLst>
          </p:cNvPr>
          <p:cNvSpPr txBox="1"/>
          <p:nvPr/>
        </p:nvSpPr>
        <p:spPr>
          <a:xfrm>
            <a:off x="10564816" y="1524526"/>
            <a:ext cx="1232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nt.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70A7695-2163-4735-BAC2-9147504A19EA}"/>
              </a:ext>
            </a:extLst>
          </p:cNvPr>
          <p:cNvSpPr txBox="1"/>
          <p:nvPr/>
        </p:nvSpPr>
        <p:spPr>
          <a:xfrm>
            <a:off x="10486477" y="1176099"/>
            <a:ext cx="1608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LF Treated 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741884-EE39-4FAD-B9D6-D77B71A34931}"/>
              </a:ext>
            </a:extLst>
          </p:cNvPr>
          <p:cNvSpPr txBox="1"/>
          <p:nvPr/>
        </p:nvSpPr>
        <p:spPr>
          <a:xfrm>
            <a:off x="2842571" y="1370638"/>
            <a:ext cx="78902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RPMI-P                                          RPMI-VR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658627" y="2585258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5%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652663" y="4616334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4.1%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776611" y="3662615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9.1%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776611" y="5722962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7.1%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857206" y="3727111"/>
            <a:ext cx="442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9.2%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846338" y="5722961"/>
            <a:ext cx="442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7.1%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067713" y="3035712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6.7%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078581" y="5023589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21.7%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9374224" y="2831822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70.3%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9374223" y="4573478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71.1%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398785" y="3785725"/>
            <a:ext cx="442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9.7%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8398785" y="5846072"/>
            <a:ext cx="442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7.2%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9587670" y="3812047"/>
            <a:ext cx="442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6.8%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587670" y="5823064"/>
            <a:ext cx="442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7.1%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776185" y="3265265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3.2%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9776184" y="5198271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4.6%</a:t>
            </a:r>
          </a:p>
        </p:txBody>
      </p:sp>
      <p:sp>
        <p:nvSpPr>
          <p:cNvPr id="5" name="Rectangle 4"/>
          <p:cNvSpPr/>
          <p:nvPr/>
        </p:nvSpPr>
        <p:spPr>
          <a:xfrm>
            <a:off x="110664" y="16974"/>
            <a:ext cx="1198435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C: Representative figures showing the effect of CLF-treatment on cell cycle progression in myeloma.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cycle analysis was performed using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ropidi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iodide (PI) staining followed by Flow cytometry analysis. When gated for live cells, the percentage of cells in G0/G1, S, G2/M, and sub G0/G1 phases in pre- vs. post- CLF treatment HMCLs are shown.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10091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50480"/>
          <a:stretch/>
        </p:blipFill>
        <p:spPr>
          <a:xfrm>
            <a:off x="6667500" y="2567017"/>
            <a:ext cx="5524500" cy="417781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t="48660"/>
          <a:stretch/>
        </p:blipFill>
        <p:spPr>
          <a:xfrm>
            <a:off x="126708" y="2607104"/>
            <a:ext cx="6401092" cy="412546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89AAD09-4A88-464C-85EB-03BC3313453F}"/>
              </a:ext>
            </a:extLst>
          </p:cNvPr>
          <p:cNvSpPr txBox="1"/>
          <p:nvPr/>
        </p:nvSpPr>
        <p:spPr>
          <a:xfrm>
            <a:off x="126708" y="2237772"/>
            <a:ext cx="2004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-</a:t>
            </a:r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B29F784-1280-486D-9C70-3774899AEAC2}"/>
              </a:ext>
            </a:extLst>
          </p:cNvPr>
          <p:cNvSpPr txBox="1"/>
          <p:nvPr/>
        </p:nvSpPr>
        <p:spPr>
          <a:xfrm>
            <a:off x="6527800" y="2197685"/>
            <a:ext cx="2004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-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3B. 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C8947B-55C7-4BAE-9CF2-A358A61C70DA}"/>
              </a:ext>
            </a:extLst>
          </p:cNvPr>
          <p:cNvSpPr txBox="1"/>
          <p:nvPr/>
        </p:nvSpPr>
        <p:spPr>
          <a:xfrm>
            <a:off x="0" y="0"/>
            <a:ext cx="1219200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/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 CLF induces Super-oxide levels, and mitochondrial membrane potential (MMP) in the myeloma cell line pair U226 P/VR cell line pair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 algn="just">
              <a:buFont typeface="+mj-lt"/>
              <a:buAutoNum type="alphaUcParenR"/>
              <a:tabLst>
                <a:tab pos="457200" algn="l"/>
              </a:tabLs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er-oxide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ular superoxide anions were measured by using the fluorescent dye DHE (Sigma) and red fluorescence was detected by flow cytometry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 algn="just">
              <a:buFont typeface="+mj-lt"/>
              <a:buAutoNum type="alphaUcParenR"/>
              <a:tabLst>
                <a:tab pos="457200" algn="l"/>
              </a:tabLs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tochondrial membrane potential (MMP)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tochondrial membrane potential was assessed using JC-1 (Sigma), a cationic carbocyanine dye that accumulates in mitochondria. Cells were incubated with 5μM JC-1 dye for 15 min in the dark at 37°C, washed twice in PBS and then analyzed for red and green fluorescence by flow cytometry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9184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>
            <a:extLst>
              <a:ext uri="{FF2B5EF4-FFF2-40B4-BE49-F238E27FC236}">
                <a16:creationId xmlns:a16="http://schemas.microsoft.com/office/drawing/2014/main" id="{CFB96825-F8C4-47A9-A572-29509A43B3BF}"/>
              </a:ext>
            </a:extLst>
          </p:cNvPr>
          <p:cNvGrpSpPr/>
          <p:nvPr/>
        </p:nvGrpSpPr>
        <p:grpSpPr>
          <a:xfrm>
            <a:off x="1699416" y="3699968"/>
            <a:ext cx="8777780" cy="2996410"/>
            <a:chOff x="-389356" y="249416"/>
            <a:chExt cx="8777780" cy="2996410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4A86B17B-33B4-42E3-80DB-57EFE95EDC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5383" y="523857"/>
              <a:ext cx="2026325" cy="1266454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56D75838-BB7B-48B2-933B-B06BAD6D63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05394" y="514292"/>
              <a:ext cx="2048069" cy="128004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43C03549-581E-4B62-8819-C7B484B59C2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69" y="545288"/>
              <a:ext cx="2055068" cy="1284418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698341DB-E084-4FB0-8A80-18E83F1EC3C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15930" y="531001"/>
              <a:ext cx="2055067" cy="1284417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EDA892A6-7C03-45CD-90B4-71A670FC3C1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03639" y="1863419"/>
              <a:ext cx="2048072" cy="1280045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8E5AEE66-F526-4CB3-B9F5-F313C33F6EF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98396" y="1863418"/>
              <a:ext cx="2055066" cy="1284416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FC5A204A-B6F4-467F-BDC9-BD64B107D34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0307" y="1870089"/>
              <a:ext cx="2080887" cy="1300555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316F5607-23A6-4981-BD26-8D282F6251F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12410" y="1870089"/>
              <a:ext cx="2055067" cy="1284417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0F7758B-16A0-4FD3-B823-FBDBCD3C6F65}"/>
                </a:ext>
              </a:extLst>
            </p:cNvPr>
            <p:cNvSpPr txBox="1"/>
            <p:nvPr/>
          </p:nvSpPr>
          <p:spPr>
            <a:xfrm>
              <a:off x="4211960" y="256509"/>
              <a:ext cx="21291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LF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06D9190-AF76-4DA4-BFA2-48BE7B588DCD}"/>
                </a:ext>
              </a:extLst>
            </p:cNvPr>
            <p:cNvSpPr txBox="1"/>
            <p:nvPr/>
          </p:nvSpPr>
          <p:spPr>
            <a:xfrm>
              <a:off x="6261973" y="249416"/>
              <a:ext cx="21264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IXA+CLF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F3AFCCF-A91C-481C-B609-2AABAC3F1DA8}"/>
                </a:ext>
              </a:extLst>
            </p:cNvPr>
            <p:cNvSpPr txBox="1"/>
            <p:nvPr/>
          </p:nvSpPr>
          <p:spPr>
            <a:xfrm>
              <a:off x="2123728" y="255494"/>
              <a:ext cx="21291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IXA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75B7F19-6B1F-4F5B-B0A1-74596CC0A9EF}"/>
                </a:ext>
              </a:extLst>
            </p:cNvPr>
            <p:cNvSpPr txBox="1"/>
            <p:nvPr/>
          </p:nvSpPr>
          <p:spPr>
            <a:xfrm>
              <a:off x="15512" y="2882696"/>
              <a:ext cx="4714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ail"/>
                  <a:ea typeface="+mn-ea"/>
                  <a:cs typeface="+mn-cs"/>
                </a:rPr>
                <a:t>4X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C8A5FFC-276E-44E3-AF81-302C31069053}"/>
                </a:ext>
              </a:extLst>
            </p:cNvPr>
            <p:cNvSpPr txBox="1"/>
            <p:nvPr/>
          </p:nvSpPr>
          <p:spPr>
            <a:xfrm>
              <a:off x="15512" y="1561424"/>
              <a:ext cx="4714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ail"/>
                  <a:ea typeface="+mn-ea"/>
                  <a:cs typeface="+mn-cs"/>
                </a:rPr>
                <a:t>4X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4B14079-363C-428B-8E61-21C9C9F9AD4D}"/>
                </a:ext>
              </a:extLst>
            </p:cNvPr>
            <p:cNvSpPr txBox="1"/>
            <p:nvPr/>
          </p:nvSpPr>
          <p:spPr>
            <a:xfrm rot="16200000">
              <a:off x="-985886" y="2303598"/>
              <a:ext cx="15459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PMI8226/VR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2A06731-78B4-4ED9-9FE2-26F844D6BAE8}"/>
                </a:ext>
              </a:extLst>
            </p:cNvPr>
            <p:cNvSpPr txBox="1"/>
            <p:nvPr/>
          </p:nvSpPr>
          <p:spPr>
            <a:xfrm rot="16200000">
              <a:off x="-896869" y="983640"/>
              <a:ext cx="135358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PMI8226/P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7F961A4-3BEC-4D7D-AE56-138B6A6836E8}"/>
                </a:ext>
              </a:extLst>
            </p:cNvPr>
            <p:cNvSpPr txBox="1"/>
            <p:nvPr/>
          </p:nvSpPr>
          <p:spPr>
            <a:xfrm>
              <a:off x="48943" y="270579"/>
              <a:ext cx="20938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V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17B93B35-96DE-464D-B213-27B29D179F1D}"/>
              </a:ext>
            </a:extLst>
          </p:cNvPr>
          <p:cNvSpPr txBox="1"/>
          <p:nvPr/>
        </p:nvSpPr>
        <p:spPr>
          <a:xfrm>
            <a:off x="56994" y="36402"/>
            <a:ext cx="120207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IN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Figure</a:t>
            </a:r>
            <a:r>
              <a:rPr kumimoji="0" lang="en-IN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</a:t>
            </a:r>
            <a:r>
              <a:rPr kumimoji="0" lang="en-IN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S4: Colony forming assay. </a:t>
            </a:r>
            <a:r>
              <a:rPr lang="en-US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LF significantly reduced colony formation in PI- sensitive and resistant HMCLs (RPMI826 P/VR and U266 P/VR) </a:t>
            </a:r>
            <a:endParaRPr kumimoji="0" lang="en-IN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ECAB1FEA-E180-4F40-AB7B-183DF66F9256}"/>
              </a:ext>
            </a:extLst>
          </p:cNvPr>
          <p:cNvGrpSpPr/>
          <p:nvPr/>
        </p:nvGrpSpPr>
        <p:grpSpPr>
          <a:xfrm>
            <a:off x="1704480" y="759752"/>
            <a:ext cx="8737272" cy="2914018"/>
            <a:chOff x="-348848" y="1268760"/>
            <a:chExt cx="8737272" cy="2914018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8603D008-3E7A-4A54-8A19-47CD895126C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778" y="2897455"/>
              <a:ext cx="2055067" cy="1284417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49834048-2715-4DBA-83DA-BE65CBDE183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5349" y="2897455"/>
              <a:ext cx="2055067" cy="1284417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7A49CE87-4EF2-44A7-8211-91A42539022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36207" y="2887987"/>
              <a:ext cx="2055067" cy="1284417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FE29ADAC-E91C-474E-981A-1E276DB0F83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29921" y="2897455"/>
              <a:ext cx="2055067" cy="1284417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467A2EAD-123E-4DC1-B8F0-ADC02FEBC39E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96" y="1556792"/>
              <a:ext cx="2080888" cy="1300555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5FEB4EBC-DCA5-4462-B3F8-6F259C4F0A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36207" y="1556792"/>
              <a:ext cx="2055067" cy="1284416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471DD9B1-8546-4450-8994-480426F423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29921" y="1567666"/>
              <a:ext cx="2055066" cy="1284416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04E44F9C-4322-41D2-92DE-CF6A357F47C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7742" y="1557434"/>
              <a:ext cx="2055067" cy="1284417"/>
            </a:xfrm>
            <a:prstGeom prst="rect">
              <a:avLst/>
            </a:prstGeom>
          </p:spPr>
        </p:pic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861021E7-780E-43FB-A3BD-B1F7EB9B6637}"/>
                </a:ext>
              </a:extLst>
            </p:cNvPr>
            <p:cNvSpPr txBox="1"/>
            <p:nvPr/>
          </p:nvSpPr>
          <p:spPr>
            <a:xfrm>
              <a:off x="40790" y="3905779"/>
              <a:ext cx="4714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ail"/>
                  <a:ea typeface="+mn-ea"/>
                  <a:cs typeface="+mn-cs"/>
                </a:rPr>
                <a:t>4X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AE7A6B5-450B-4152-BE51-6C54BE2301FD}"/>
                </a:ext>
              </a:extLst>
            </p:cNvPr>
            <p:cNvSpPr txBox="1"/>
            <p:nvPr/>
          </p:nvSpPr>
          <p:spPr>
            <a:xfrm>
              <a:off x="55077" y="2610988"/>
              <a:ext cx="4714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ail"/>
                  <a:ea typeface="+mn-ea"/>
                  <a:cs typeface="+mn-cs"/>
                </a:rPr>
                <a:t>4X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67ADFB2-54B9-4B62-8721-7A30983ECA2B}"/>
                </a:ext>
              </a:extLst>
            </p:cNvPr>
            <p:cNvSpPr txBox="1"/>
            <p:nvPr/>
          </p:nvSpPr>
          <p:spPr>
            <a:xfrm rot="16200000">
              <a:off x="-712942" y="3319945"/>
              <a:ext cx="10667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U266/VR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599D286-C28E-4E5A-A715-09BC55A05470}"/>
                </a:ext>
              </a:extLst>
            </p:cNvPr>
            <p:cNvSpPr txBox="1"/>
            <p:nvPr/>
          </p:nvSpPr>
          <p:spPr>
            <a:xfrm rot="16200000">
              <a:off x="-698656" y="2018010"/>
              <a:ext cx="10667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U266/P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7EA9FBE-204E-4BCB-9A3F-6FFCD4F1DDB1}"/>
                </a:ext>
              </a:extLst>
            </p:cNvPr>
            <p:cNvSpPr txBox="1"/>
            <p:nvPr/>
          </p:nvSpPr>
          <p:spPr>
            <a:xfrm>
              <a:off x="4186270" y="1269775"/>
              <a:ext cx="212912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LF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26FEEF9-0651-42E6-88B6-07826164D871}"/>
                </a:ext>
              </a:extLst>
            </p:cNvPr>
            <p:cNvSpPr txBox="1"/>
            <p:nvPr/>
          </p:nvSpPr>
          <p:spPr>
            <a:xfrm>
              <a:off x="6261973" y="1281343"/>
              <a:ext cx="21264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IXA+CLF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8B946BA-2371-4C2B-BB47-E6420D9FDCF3}"/>
                </a:ext>
              </a:extLst>
            </p:cNvPr>
            <p:cNvSpPr txBox="1"/>
            <p:nvPr/>
          </p:nvSpPr>
          <p:spPr>
            <a:xfrm>
              <a:off x="2195736" y="1268760"/>
              <a:ext cx="212912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IXA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9A732DC-6E24-42B3-B070-A867D319DB51}"/>
                </a:ext>
              </a:extLst>
            </p:cNvPr>
            <p:cNvSpPr txBox="1"/>
            <p:nvPr/>
          </p:nvSpPr>
          <p:spPr>
            <a:xfrm>
              <a:off x="3376" y="1285331"/>
              <a:ext cx="20938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89739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6057" t="67171"/>
          <a:stretch/>
        </p:blipFill>
        <p:spPr>
          <a:xfrm>
            <a:off x="67011" y="4491074"/>
            <a:ext cx="6098120" cy="230807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46643" b="-1"/>
          <a:stretch/>
        </p:blipFill>
        <p:spPr>
          <a:xfrm>
            <a:off x="6135990" y="2229646"/>
            <a:ext cx="5988999" cy="328658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4141018-C20B-4B4E-B632-32EA220142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25" b="66421"/>
          <a:stretch/>
        </p:blipFill>
        <p:spPr>
          <a:xfrm>
            <a:off x="50319" y="2218065"/>
            <a:ext cx="6067360" cy="234314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19BA996-54A3-40C7-8C06-14EC648F0336}"/>
              </a:ext>
            </a:extLst>
          </p:cNvPr>
          <p:cNvSpPr txBox="1"/>
          <p:nvPr/>
        </p:nvSpPr>
        <p:spPr>
          <a:xfrm>
            <a:off x="50319" y="1883801"/>
            <a:ext cx="1557868" cy="3886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-S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A578E29-DC09-46A1-91AF-94E26EB9D43F}"/>
              </a:ext>
            </a:extLst>
          </p:cNvPr>
          <p:cNvSpPr txBox="1"/>
          <p:nvPr/>
        </p:nvSpPr>
        <p:spPr>
          <a:xfrm>
            <a:off x="6096000" y="1883801"/>
            <a:ext cx="1923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-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B. 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B89C7C1-CA84-410C-9CD2-696448031ED9}"/>
              </a:ext>
            </a:extLst>
          </p:cNvPr>
          <p:cNvSpPr txBox="1"/>
          <p:nvPr/>
        </p:nvSpPr>
        <p:spPr>
          <a:xfrm>
            <a:off x="140747" y="58847"/>
            <a:ext cx="11910506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: CLF kills MM cells with cancer stem-like properties (CSCs). </a:t>
            </a:r>
          </a:p>
          <a:p>
            <a:pPr marL="342900" indent="-342900">
              <a:buFont typeface="+mj-lt"/>
              <a:buAutoNum type="alphaU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F reduces Aldefluor (ALDH) activity in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Innate sensitive (FLAM76) and resistant (LP-1) pair; and ii) Acquired sensitive (U266P) and resistant (U266 VR) pair. </a:t>
            </a:r>
          </a:p>
          <a:p>
            <a:pPr marL="342900" indent="-342900">
              <a:buFont typeface="+mj-lt"/>
              <a:buAutoNum type="alphaU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F erodes quiescent CD138+ (CFSE bright) cells. </a:t>
            </a:r>
          </a:p>
          <a:p>
            <a:pPr marL="342900" indent="-342900">
              <a:buFont typeface="+mj-lt"/>
              <a:buAutoNum type="alphaU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F erodes Side Population (SP) cells in myeloma.</a:t>
            </a:r>
          </a:p>
        </p:txBody>
      </p:sp>
    </p:spTree>
    <p:extLst>
      <p:ext uri="{BB962C8B-B14F-4D97-AF65-F5344CB8AC3E}">
        <p14:creationId xmlns:p14="http://schemas.microsoft.com/office/powerpoint/2010/main" val="12818057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BCA0AE5D-69AD-4165-8651-EE73E12C6F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964"/>
          <a:stretch/>
        </p:blipFill>
        <p:spPr>
          <a:xfrm>
            <a:off x="877389" y="975167"/>
            <a:ext cx="10575423" cy="496843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0A66E0B-1660-4B02-AF58-5B966C0897F1}"/>
              </a:ext>
            </a:extLst>
          </p:cNvPr>
          <p:cNvSpPr txBox="1"/>
          <p:nvPr/>
        </p:nvSpPr>
        <p:spPr>
          <a:xfrm>
            <a:off x="877389" y="605835"/>
            <a:ext cx="1923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C. </a:t>
            </a:r>
          </a:p>
        </p:txBody>
      </p:sp>
    </p:spTree>
    <p:extLst>
      <p:ext uri="{BB962C8B-B14F-4D97-AF65-F5344CB8AC3E}">
        <p14:creationId xmlns:p14="http://schemas.microsoft.com/office/powerpoint/2010/main" val="6289830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320172-3B48-459A-AA12-0EECBFB59D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70315"/>
            <a:ext cx="11864951" cy="628788"/>
          </a:xfrm>
        </p:spPr>
        <p:txBody>
          <a:bodyPr>
            <a:no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6. H</a:t>
            </a:r>
            <a:r>
              <a:rPr lang="en-US" sz="2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tmap of the genes that were significant in either CLF vs CON and/or CLF+IXA vs CON with LS mean&gt;=1 and ANOVA p value&lt;0.05.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860F09C-5F76-4046-AADD-0A2C29C9466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900"/>
          <a:stretch/>
        </p:blipFill>
        <p:spPr>
          <a:xfrm>
            <a:off x="149001" y="1063181"/>
            <a:ext cx="12002994" cy="4873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16955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C3486-C2C5-4E97-AE39-0F862A4B3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752168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7: Volcano plots of pre vs post treatment GEP: pairwise comparisons</a:t>
            </a:r>
          </a:p>
        </p:txBody>
      </p:sp>
      <p:pic>
        <p:nvPicPr>
          <p:cNvPr id="4" name="Picture 3" descr="Chart, bar chart&#10;&#10;Description automatically generated">
            <a:extLst>
              <a:ext uri="{FF2B5EF4-FFF2-40B4-BE49-F238E27FC236}">
                <a16:creationId xmlns:a16="http://schemas.microsoft.com/office/drawing/2014/main" id="{AC1DB48B-9C19-4D81-BDF5-854B1796D3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07" r="-1"/>
          <a:stretch/>
        </p:blipFill>
        <p:spPr>
          <a:xfrm>
            <a:off x="427705" y="1438582"/>
            <a:ext cx="5672842" cy="46672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Chart, bar chart&#10;&#10;Description automatically generated">
            <a:extLst>
              <a:ext uri="{FF2B5EF4-FFF2-40B4-BE49-F238E27FC236}">
                <a16:creationId xmlns:a16="http://schemas.microsoft.com/office/drawing/2014/main" id="{73D888CD-D655-4EFA-B46E-55C44EE17A4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82"/>
          <a:stretch/>
        </p:blipFill>
        <p:spPr>
          <a:xfrm>
            <a:off x="6356926" y="1438582"/>
            <a:ext cx="5672842" cy="46672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EAB05B0-A5D1-4BBD-BA6D-DD1AFCF16996}"/>
              </a:ext>
            </a:extLst>
          </p:cNvPr>
          <p:cNvSpPr txBox="1"/>
          <p:nvPr/>
        </p:nvSpPr>
        <p:spPr>
          <a:xfrm>
            <a:off x="1996635" y="1069250"/>
            <a:ext cx="15069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Calibri" panose="020F0502020204030204"/>
              </a:rPr>
              <a:t>CLF vs Control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B8B3684-B9F3-4392-B1AB-4A2ABCC6F5A1}"/>
              </a:ext>
            </a:extLst>
          </p:cNvPr>
          <p:cNvSpPr txBox="1"/>
          <p:nvPr/>
        </p:nvSpPr>
        <p:spPr>
          <a:xfrm>
            <a:off x="7419194" y="1019628"/>
            <a:ext cx="37723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b="1" dirty="0">
                <a:solidFill>
                  <a:prstClr val="black"/>
                </a:solidFill>
                <a:latin typeface="Calibri" panose="020F0502020204030204"/>
              </a:rPr>
              <a:t>Combination (CLF+IXA) vs Control</a:t>
            </a:r>
          </a:p>
        </p:txBody>
      </p:sp>
    </p:spTree>
    <p:extLst>
      <p:ext uri="{BB962C8B-B14F-4D97-AF65-F5344CB8AC3E}">
        <p14:creationId xmlns:p14="http://schemas.microsoft.com/office/powerpoint/2010/main" val="4143898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1</TotalTime>
  <Words>785</Words>
  <Application>Microsoft Office PowerPoint</Application>
  <PresentationFormat>Widescreen</PresentationFormat>
  <Paragraphs>90</Paragraphs>
  <Slides>1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ail</vt:lpstr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Figure S6. Heatmap of the genes that were significant in either CLF vs CON and/or CLF+IXA vs CON with LS mean&gt;=1 and ANOVA p value&lt;0.05.</vt:lpstr>
      <vt:lpstr>Figure S7: Volcano plots of pre vs post treatment GEP: pairwise comparisons</vt:lpstr>
      <vt:lpstr>PowerPoint Presentation</vt:lpstr>
      <vt:lpstr>PowerPoint Presentation</vt:lpstr>
      <vt:lpstr>PowerPoint Presentation</vt:lpstr>
    </vt:vector>
  </TitlesOfParts>
  <Company>Aubur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man Mazumder</dc:creator>
  <cp:lastModifiedBy>AMIT MITRA</cp:lastModifiedBy>
  <cp:revision>56</cp:revision>
  <cp:lastPrinted>2021-12-21T00:58:57Z</cp:lastPrinted>
  <dcterms:created xsi:type="dcterms:W3CDTF">2021-08-16T17:12:24Z</dcterms:created>
  <dcterms:modified xsi:type="dcterms:W3CDTF">2022-03-24T20:16:42Z</dcterms:modified>
</cp:coreProperties>
</file>